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60" r:id="rId4"/>
    <p:sldId id="261" r:id="rId5"/>
    <p:sldId id="258" r:id="rId6"/>
    <p:sldId id="259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81213"/>
  </p:normalViewPr>
  <p:slideViewPr>
    <p:cSldViewPr snapToGrid="0">
      <p:cViewPr varScale="1">
        <p:scale>
          <a:sx n="94" d="100"/>
          <a:sy n="94" d="100"/>
        </p:scale>
        <p:origin x="1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7A995D-EADD-E24F-BD76-F2089F7D5731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2E2334-9850-4B49-AAA2-C72A4DACB1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6662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bbreviations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valid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ll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les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:</a:t>
            </a:r>
            <a:endParaRPr lang="de-DE" sz="1200" dirty="0">
              <a:solidFill>
                <a:srgbClr val="0E0E0E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isoprolo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Lisinopril,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pironolacton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pinephrin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MB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myocardia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VI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ravenou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mmunoglobulin,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vosimenda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VED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nd-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iameter;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VE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VEDp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nd-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essur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ilrinon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I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gnet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onanc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maging,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epinephrin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B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lmonar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ter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anding; </a:t>
            </a:r>
          </a:p>
          <a:p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S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trictiv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trial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pta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fec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VE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Right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lang="de-DE" sz="1200" dirty="0">
              <a:solidFill>
                <a:srgbClr val="0E0E0E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1a:</a:t>
            </a:r>
          </a:p>
          <a:p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None/>
            </a:pP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dified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Ross Classifica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diatr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adin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Class III–IV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flect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oderate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ver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ymptom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EF)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ssess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mpson’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tho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hocardiograph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EF &lt;30%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ver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LV)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ystol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ysfun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itral Regurgita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ad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lou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opple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hocardiograph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verit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alv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volvemen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VEDD (mm /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score)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nd-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iameter,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ex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rfac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score &gt; +4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LV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lata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ssociat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dverse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I-LVE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LV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rdia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I (%)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te Enhancemen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Presence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t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dolinium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hancemen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n MRI;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yocardia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brosi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flamma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VE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Right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via MRI (%)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VEDp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l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nd-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essur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mH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rdia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theteriza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NP-Leve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Brain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atriuret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eptide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;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levat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flec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verit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vidence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arvoB19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voviru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19 DNA in EMB (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myocardia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and/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CR.</a:t>
            </a:r>
          </a:p>
          <a:p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netic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stin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Screening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thogenic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ariant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ssociat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rdiomyopath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</a:b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2E2334-9850-4B49-AAA2-C72A4DACB126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26589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le 1b: </a:t>
            </a:r>
          </a:p>
          <a:p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ameter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ntilation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uscitation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ed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ultiple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otropic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ents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rv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rker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verit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inical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urs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otropic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pport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clude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cation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a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prov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ocardial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ractilit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ndar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rt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ilure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eatment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ur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nter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ipl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a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rap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soprolol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ß1-blocker, Lisinopri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 AC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hibitor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ironolacton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neralocorticoi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eptor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agonis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ient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firm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ocarditi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l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eiv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ravenous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globulin</a:t>
            </a:r>
            <a:r>
              <a:rPr lang="de-D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IVIG)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ti-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lammator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rap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reatio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S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dicate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ether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trictiv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tria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ptal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fec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d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compres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f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rium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reb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uc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ulmonar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nou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gestio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In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ien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#1, an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ist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tent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ame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vale was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lat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stea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reat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w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D.</a:t>
            </a:r>
          </a:p>
          <a:p>
            <a:endParaRPr lang="de-DE" dirty="0"/>
          </a:p>
          <a:p>
            <a:endParaRPr lang="de-DE" dirty="0"/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None/>
            </a:pP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Table1b: </a:t>
            </a:r>
          </a:p>
          <a:p>
            <a:pPr>
              <a:buNone/>
            </a:pP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VIG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ravenous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mmunoglobulin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dminister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reation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S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trictive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trial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ptal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fect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S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reat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via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theterizatio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n evident </a:t>
            </a:r>
            <a:r>
              <a:rPr lang="de-DE" sz="1200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FO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Patent </a:t>
            </a:r>
            <a:r>
              <a:rPr lang="de-DE" sz="120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amen</a:t>
            </a:r>
            <a:r>
              <a:rPr lang="de-DE" sz="120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vale).</a:t>
            </a: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2E2334-9850-4B49-AAA2-C72A4DACB126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18932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le 2: </a:t>
            </a:r>
          </a:p>
          <a:p>
            <a:pPr>
              <a:spcBef>
                <a:spcPts val="900"/>
              </a:spcBef>
              <a:buNone/>
            </a:pPr>
            <a:endParaRPr lang="de-DE" b="1" dirty="0">
              <a:solidFill>
                <a:srgbClr val="0E0E0E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I-LVE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%)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rdia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I at last follow-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ystol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VE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Right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je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%)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I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VEDd in mm (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score)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ricula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nd-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stol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iameter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score;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a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≈ 0)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flect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olu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la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NP-Level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/m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Brain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atriuret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eptide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t follow-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;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gges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mproved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rdia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rt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dica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tinua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ral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BLS: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isoprolo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Lisinopril,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pironolacton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tial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band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hethe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lmonar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ter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and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PAB) was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tiall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leased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via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theter-based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essure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Gradient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band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Doppler-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adien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ros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AB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artial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band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mH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llow-Up (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Duration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linica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follow-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fter initial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</a:pP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dified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Ros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Ross Classification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diatr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Class I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linica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t follow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2E2334-9850-4B49-AAA2-C72A4DACB126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73676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le 3</a:t>
            </a:r>
          </a:p>
          <a:p>
            <a:pPr>
              <a:spcBef>
                <a:spcPts val="900"/>
              </a:spcBef>
              <a:buNone/>
            </a:pPr>
            <a:endParaRPr lang="de-DE" dirty="0">
              <a:solidFill>
                <a:srgbClr val="0E0E0E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1st and 2nd EMB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Timing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domyocardia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la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itial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linica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urs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-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filtrat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D3+ T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er mm²; values &gt;14/mm²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sistent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ymphocyt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yocarditi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Presence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yocardia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ath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allmark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ut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flamma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jur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spcBef>
                <a:spcPts val="900"/>
              </a:spcBef>
              <a:buNone/>
            </a:pP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brosi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Degree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brot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model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minor,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iffuse); diffuse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brosi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flect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yocardial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mag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adverse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modeling</a:t>
            </a:r>
            <a:endParaRPr lang="de-DE" dirty="0">
              <a:solidFill>
                <a:srgbClr val="0E0E0E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900"/>
              </a:spcBef>
              <a:buNone/>
            </a:pP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rsistence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arvoB19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vovirus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19 DNA via PCR in EMB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t time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ngoing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viral </a:t>
            </a:r>
            <a:r>
              <a:rPr lang="de-DE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esence</a:t>
            </a:r>
            <a: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buNone/>
            </a:pPr>
            <a:br>
              <a:rPr lang="de-DE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de-DE" b="1" dirty="0">
              <a:solidFill>
                <a:srgbClr val="0E0E0E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None/>
            </a:pPr>
            <a:r>
              <a:rPr lang="de-DE" b="1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erpretation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9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rst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MBs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firmed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ute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ymphocytic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yocarditis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high T-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filtration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esence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brosis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EMB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nsition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ute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flammation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ructural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modeling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ossible adverse </a:t>
            </a:r>
            <a:r>
              <a:rPr lang="de-DE" b="0" dirty="0" err="1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  <a:r>
              <a:rPr lang="de-DE" b="0" dirty="0">
                <a:solidFill>
                  <a:srgbClr val="0E0E0E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Patient 1,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con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MB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i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x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ek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veal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erg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ffus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brosi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spit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uc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lammatio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mpt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imel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B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errup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vers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odel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endParaRPr lang="de-DE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all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ient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sistenc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rvoB19 was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t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but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brosi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howed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gressio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year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fter PAB,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ggest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ctiv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odel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ec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se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quential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nding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ighlight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itio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om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lammation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brosi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derlin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rehensive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roach's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ect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n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hancing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ctional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de-DE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overy</a:t>
            </a:r>
            <a:r>
              <a:rPr lang="de-D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2E2334-9850-4B49-AAA2-C72A4DACB126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664711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b="1" i="0" u="none" strike="noStrike" dirty="0" err="1">
                <a:solidFill>
                  <a:srgbClr val="1C1C1C"/>
                </a:solidFill>
                <a:effectLst/>
                <a:latin typeface="Inter"/>
              </a:rPr>
              <a:t>Figures</a:t>
            </a:r>
            <a:r>
              <a:rPr lang="de-DE" b="1" i="0" u="none" strike="noStrike" dirty="0">
                <a:solidFill>
                  <a:srgbClr val="1C1C1C"/>
                </a:solidFill>
                <a:effectLst/>
                <a:latin typeface="Inter"/>
              </a:rPr>
              <a:t> 1 and 2 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MRI, 4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chamber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view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befor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creating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rASD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nd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performing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 PAB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with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reduced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funct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of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both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ventricle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, LVEF 19%, RVEF 35%, 4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chamber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view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with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normalized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funct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2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year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fter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Pulmonar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Arter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Banding, LVEF 67%, RVEF 65%  </a:t>
            </a:r>
          </a:p>
          <a:p>
            <a:r>
              <a:rPr lang="de-DE" b="1" i="0" u="none" strike="noStrike" dirty="0" err="1">
                <a:solidFill>
                  <a:srgbClr val="1C1C1C"/>
                </a:solidFill>
                <a:effectLst/>
                <a:latin typeface="Inter"/>
              </a:rPr>
              <a:t>Figures</a:t>
            </a:r>
            <a:r>
              <a:rPr lang="de-DE" b="1" i="0" u="none" strike="noStrike" dirty="0">
                <a:solidFill>
                  <a:srgbClr val="1C1C1C"/>
                </a:solidFill>
                <a:effectLst/>
                <a:latin typeface="Inter"/>
              </a:rPr>
              <a:t> 3 and 4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llustrat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h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result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of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Masson’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richrom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staining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,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highlighting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significant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fibrosi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in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h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initial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endomyocardial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biops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(EMB). In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contrast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,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h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follow-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up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biops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display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predominantl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ntact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muscl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fiber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. The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first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biops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reveal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 substantial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ncreas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in MHC II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express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nd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macrophag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nfiltrat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,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ndicating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activ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nflammat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. In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contrast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,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h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follow-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up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biops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show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resolut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of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hes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inflammatory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markers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,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suggesting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a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normalization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of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h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 </a:t>
            </a:r>
            <a:r>
              <a:rPr lang="de-DE" b="0" i="0" u="none" strike="noStrike" dirty="0" err="1">
                <a:solidFill>
                  <a:srgbClr val="1C1C1C"/>
                </a:solidFill>
                <a:effectLst/>
                <a:latin typeface="Inter"/>
              </a:rPr>
              <a:t>tissue</a:t>
            </a:r>
            <a:r>
              <a:rPr lang="de-DE" b="0" i="0" u="none" strike="noStrike" dirty="0">
                <a:solidFill>
                  <a:srgbClr val="1C1C1C"/>
                </a:solidFill>
                <a:effectLst/>
                <a:latin typeface="Inter"/>
              </a:rPr>
              <a:t>.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2E2334-9850-4B49-AAA2-C72A4DACB126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41263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99667A-85A7-19A8-DB79-6750BF18E6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C562A4A-1639-C7C8-7F92-446B8AEDD3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3A38DE-B7DE-9D29-B184-AA7DA3C03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EAEF321-C265-EC7B-0733-C0EAFED49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8ECADEF-5111-2FBA-F86B-200074988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778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BF50F0-A59B-BD14-88D9-10AC0F9F75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1C3CCBF-38E8-1ACB-BFA5-DCFA42F41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BBD3414-1EFC-AF79-66F7-EC7F741CE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30AA706-8CB0-BAAF-F208-6502E39AD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156DB46-07A4-A0B1-446A-8E791267D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873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3C94ED0-1CEC-F38A-AC7D-A784EF0BAE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7F1D1D4-8E16-2F61-4E84-D654FA6933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2BC64F-1D70-7324-1D77-61DBF9090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3AE165E-8934-3990-A10D-D399EAD66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FA76C51-7BD0-E418-321E-01375400A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1209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6F2726-823A-6B01-1B89-FDEBDF5764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EDD4C77-D635-E5B1-A734-6BD62CDBA2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7B913DD-79EF-CE9C-0936-A8B96B86D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5C8111C-2147-91CD-5747-6602BEB78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B54BABA-090E-854B-3BEB-85B2E7101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1094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8264B0-DBEB-7072-DA3A-065B435EB1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80E6A5A-2BF2-C240-5CD9-20CECF6F6A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65950DA-E89E-6FD2-4187-F24C091BD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D70F52B-5FF4-72EA-7E6B-60F4A7EA8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74E7209-4CFA-DFC0-044F-AA7DCFE18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533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B8E3E4-49B7-4BF1-FFFC-E1790108E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CFB1DEE-48B9-F148-5959-DBA18120C4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98D7671-B5D7-3D1E-3156-FD961C3364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0D32335-B415-AD51-7835-5D6E6C17D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B8F43C0-3FE1-2BE7-C00C-3BB83BA08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7D238AB-1EF6-F34E-F5D7-F272B44FA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4080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CDC3325-FD1D-4EB6-A1FE-1AA2DA062F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43D9973-FBE5-0281-3B20-3779DD5471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47899BC-71A3-EBA7-7229-20305F217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80EE1A5-F1A1-9E64-9DDC-E2AB2E402D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B5AEE8E-F641-97F4-A575-40B55B9B8E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B6D90A2-9311-54A6-B4FC-9A1F0273D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A52639E-58FE-2A1B-B45D-68ED992AC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36D4800-B77F-6919-A9E8-1CCA7E72F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736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E3BF60-7577-9B93-5A02-CFD127A3CE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9A38007-A35C-E4D9-3527-82A0996FA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932B93A-9C66-8F49-5F89-F4952E279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C934416-68F6-36AC-1745-3181C1F29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2907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87410F3-E99C-A94A-D1CC-9E4F26628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E5BA226-FAE3-6910-E7EB-537F795E0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C09C050-5F9F-AFBE-4DED-B372CC718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5987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B7ADC13-482E-3E78-381A-096F33D99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0220947-3C57-DA54-27C9-031EDEB0D5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A5A24D9-910A-42F2-9568-B82148BA96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39BFD65-9EDE-84C4-74E2-67E63240E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2CFCD6F-5F80-A5F6-E23B-7216BAF34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E7F9527-7F51-CC90-54D9-FBA7054AE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1333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C1C3F4-2537-68E5-5B13-EA6C75ABA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02DABA54-0121-172F-E415-C606C2D370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3651AE7-952C-1AD9-81F2-551B574436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C65F83F-1495-4971-1E33-F01F3DC79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883EBF0-020F-3C09-0F7E-B6B10490E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41BD908-C188-B0EE-CF59-7478ECA7F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6577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F43C49C-0CDD-800D-7952-23F79274C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4E33D7F-5000-FD19-673C-B4CB177911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6620002-717F-1624-6F7A-765A7B329C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7F41302-6758-4441-BA05-DE5B454CE319}" type="datetimeFigureOut">
              <a:rPr lang="de-DE" smtClean="0"/>
              <a:t>21.05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4B651C-331C-0DFE-8BC4-4695B26806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A925FD9-CCD4-CE5A-DB08-49E0F578DE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72081E-29AD-9D4A-90AC-AFEC796A78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8075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338264-2E7F-6697-3C7C-49B0C74DE3C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pPr algn="ctr">
              <a:spcBef>
                <a:spcPts val="1200"/>
              </a:spcBef>
              <a:spcAft>
                <a:spcPts val="1800"/>
              </a:spcAft>
            </a:pP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ase Series: Full Recovery in Severe ParvoB19 Myocarditis with DCM Phenotype: The Impact of </a:t>
            </a:r>
            <a:r>
              <a:rPr lang="en-US" sz="2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ASD</a:t>
            </a: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reation and Pulmonary Banding</a:t>
            </a:r>
            <a:b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</a:br>
            <a:b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</a:br>
            <a:r>
              <a:rPr lang="en-US" sz="3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ables and Figures</a:t>
            </a:r>
            <a:endParaRPr lang="de-DE" sz="18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0998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FA0F4A72-0F69-AF71-8969-54A24FAFF4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6727201"/>
              </p:ext>
            </p:extLst>
          </p:nvPr>
        </p:nvGraphicFramePr>
        <p:xfrm>
          <a:off x="0" y="1159411"/>
          <a:ext cx="12106787" cy="17678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71777">
                  <a:extLst>
                    <a:ext uri="{9D8B030D-6E8A-4147-A177-3AD203B41FA5}">
                      <a16:colId xmlns:a16="http://schemas.microsoft.com/office/drawing/2014/main" val="2427005933"/>
                    </a:ext>
                  </a:extLst>
                </a:gridCol>
                <a:gridCol w="769878">
                  <a:extLst>
                    <a:ext uri="{9D8B030D-6E8A-4147-A177-3AD203B41FA5}">
                      <a16:colId xmlns:a16="http://schemas.microsoft.com/office/drawing/2014/main" val="553324753"/>
                    </a:ext>
                  </a:extLst>
                </a:gridCol>
                <a:gridCol w="832546">
                  <a:extLst>
                    <a:ext uri="{9D8B030D-6E8A-4147-A177-3AD203B41FA5}">
                      <a16:colId xmlns:a16="http://schemas.microsoft.com/office/drawing/2014/main" val="4138147272"/>
                    </a:ext>
                  </a:extLst>
                </a:gridCol>
                <a:gridCol w="824176">
                  <a:extLst>
                    <a:ext uri="{9D8B030D-6E8A-4147-A177-3AD203B41FA5}">
                      <a16:colId xmlns:a16="http://schemas.microsoft.com/office/drawing/2014/main" val="3384759797"/>
                    </a:ext>
                  </a:extLst>
                </a:gridCol>
                <a:gridCol w="877871">
                  <a:extLst>
                    <a:ext uri="{9D8B030D-6E8A-4147-A177-3AD203B41FA5}">
                      <a16:colId xmlns:a16="http://schemas.microsoft.com/office/drawing/2014/main" val="371279077"/>
                    </a:ext>
                  </a:extLst>
                </a:gridCol>
                <a:gridCol w="875932">
                  <a:extLst>
                    <a:ext uri="{9D8B030D-6E8A-4147-A177-3AD203B41FA5}">
                      <a16:colId xmlns:a16="http://schemas.microsoft.com/office/drawing/2014/main" val="2726266059"/>
                    </a:ext>
                  </a:extLst>
                </a:gridCol>
                <a:gridCol w="996311">
                  <a:extLst>
                    <a:ext uri="{9D8B030D-6E8A-4147-A177-3AD203B41FA5}">
                      <a16:colId xmlns:a16="http://schemas.microsoft.com/office/drawing/2014/main" val="2289091844"/>
                    </a:ext>
                  </a:extLst>
                </a:gridCol>
                <a:gridCol w="769787">
                  <a:extLst>
                    <a:ext uri="{9D8B030D-6E8A-4147-A177-3AD203B41FA5}">
                      <a16:colId xmlns:a16="http://schemas.microsoft.com/office/drawing/2014/main" val="998944462"/>
                    </a:ext>
                  </a:extLst>
                </a:gridCol>
                <a:gridCol w="769787">
                  <a:extLst>
                    <a:ext uri="{9D8B030D-6E8A-4147-A177-3AD203B41FA5}">
                      <a16:colId xmlns:a16="http://schemas.microsoft.com/office/drawing/2014/main" val="354339465"/>
                    </a:ext>
                  </a:extLst>
                </a:gridCol>
                <a:gridCol w="769787">
                  <a:extLst>
                    <a:ext uri="{9D8B030D-6E8A-4147-A177-3AD203B41FA5}">
                      <a16:colId xmlns:a16="http://schemas.microsoft.com/office/drawing/2014/main" val="256845878"/>
                    </a:ext>
                  </a:extLst>
                </a:gridCol>
                <a:gridCol w="769787">
                  <a:extLst>
                    <a:ext uri="{9D8B030D-6E8A-4147-A177-3AD203B41FA5}">
                      <a16:colId xmlns:a16="http://schemas.microsoft.com/office/drawing/2014/main" val="306746393"/>
                    </a:ext>
                  </a:extLst>
                </a:gridCol>
                <a:gridCol w="769787">
                  <a:extLst>
                    <a:ext uri="{9D8B030D-6E8A-4147-A177-3AD203B41FA5}">
                      <a16:colId xmlns:a16="http://schemas.microsoft.com/office/drawing/2014/main" val="2136145375"/>
                    </a:ext>
                  </a:extLst>
                </a:gridCol>
                <a:gridCol w="679707">
                  <a:extLst>
                    <a:ext uri="{9D8B030D-6E8A-4147-A177-3AD203B41FA5}">
                      <a16:colId xmlns:a16="http://schemas.microsoft.com/office/drawing/2014/main" val="1561540598"/>
                    </a:ext>
                  </a:extLst>
                </a:gridCol>
                <a:gridCol w="859867">
                  <a:extLst>
                    <a:ext uri="{9D8B030D-6E8A-4147-A177-3AD203B41FA5}">
                      <a16:colId xmlns:a16="http://schemas.microsoft.com/office/drawing/2014/main" val="2909868867"/>
                    </a:ext>
                  </a:extLst>
                </a:gridCol>
                <a:gridCol w="769787">
                  <a:extLst>
                    <a:ext uri="{9D8B030D-6E8A-4147-A177-3AD203B41FA5}">
                      <a16:colId xmlns:a16="http://schemas.microsoft.com/office/drawing/2014/main" val="2335370482"/>
                    </a:ext>
                  </a:extLst>
                </a:gridCol>
              </a:tblGrid>
              <a:tr h="615411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Patient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Age (months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Gender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Modified Ross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Body weight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Ejection fraction at admission (ECHO, Simpson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Mitral regurgitation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 err="1">
                          <a:effectLst/>
                        </a:rPr>
                        <a:t>LVEDd</a:t>
                      </a:r>
                      <a:r>
                        <a:rPr lang="en-US" sz="1000" kern="100" dirty="0">
                          <a:effectLst/>
                        </a:rPr>
                        <a:t>  mm </a:t>
                      </a:r>
                    </a:p>
                    <a:p>
                      <a:r>
                        <a:rPr lang="en-US" sz="1000" kern="100" dirty="0">
                          <a:effectLst/>
                        </a:rPr>
                        <a:t>(z-score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RI-LVEF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ate-Enhancement 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RI-RVEF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VEDp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NP-Level (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/ml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vidence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B19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enetic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testing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2026410288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1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15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female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IV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1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20%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II° 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48 (+5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8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224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MB/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lood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1333924574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2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6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male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IV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5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25%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II°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50 (+4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976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MB/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lood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, normal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1729078831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3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7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female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III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0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0%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II°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48 (+6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16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lood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956103878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4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6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female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III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2</a:t>
                      </a:r>
                      <a:endParaRPr lang="de-D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25%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II°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51 (+5)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4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394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MB/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lood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, normal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2466319785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39CBC0F4-65BD-57CE-EE14-79E3012ACE22}"/>
              </a:ext>
            </a:extLst>
          </p:cNvPr>
          <p:cNvSpPr txBox="1"/>
          <p:nvPr/>
        </p:nvSpPr>
        <p:spPr>
          <a:xfrm>
            <a:off x="541610" y="775728"/>
            <a:ext cx="6078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able 1a: Clinical and diagnostic Data at admission  </a:t>
            </a:r>
          </a:p>
        </p:txBody>
      </p:sp>
    </p:spTree>
    <p:extLst>
      <p:ext uri="{BB962C8B-B14F-4D97-AF65-F5344CB8AC3E}">
        <p14:creationId xmlns:p14="http://schemas.microsoft.com/office/powerpoint/2010/main" val="37813929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92057994-9C3B-4B53-B56E-7AC8F2E183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0828479"/>
              </p:ext>
            </p:extLst>
          </p:nvPr>
        </p:nvGraphicFramePr>
        <p:xfrm>
          <a:off x="302459" y="1174968"/>
          <a:ext cx="7656687" cy="179014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15662">
                  <a:extLst>
                    <a:ext uri="{9D8B030D-6E8A-4147-A177-3AD203B41FA5}">
                      <a16:colId xmlns:a16="http://schemas.microsoft.com/office/drawing/2014/main" val="2427005933"/>
                    </a:ext>
                  </a:extLst>
                </a:gridCol>
                <a:gridCol w="989346">
                  <a:extLst>
                    <a:ext uri="{9D8B030D-6E8A-4147-A177-3AD203B41FA5}">
                      <a16:colId xmlns:a16="http://schemas.microsoft.com/office/drawing/2014/main" val="553324753"/>
                    </a:ext>
                  </a:extLst>
                </a:gridCol>
                <a:gridCol w="1120565">
                  <a:extLst>
                    <a:ext uri="{9D8B030D-6E8A-4147-A177-3AD203B41FA5}">
                      <a16:colId xmlns:a16="http://schemas.microsoft.com/office/drawing/2014/main" val="4138147272"/>
                    </a:ext>
                  </a:extLst>
                </a:gridCol>
                <a:gridCol w="1320531">
                  <a:extLst>
                    <a:ext uri="{9D8B030D-6E8A-4147-A177-3AD203B41FA5}">
                      <a16:colId xmlns:a16="http://schemas.microsoft.com/office/drawing/2014/main" val="3384759797"/>
                    </a:ext>
                  </a:extLst>
                </a:gridCol>
                <a:gridCol w="1066330">
                  <a:extLst>
                    <a:ext uri="{9D8B030D-6E8A-4147-A177-3AD203B41FA5}">
                      <a16:colId xmlns:a16="http://schemas.microsoft.com/office/drawing/2014/main" val="4097752585"/>
                    </a:ext>
                  </a:extLst>
                </a:gridCol>
                <a:gridCol w="681955">
                  <a:extLst>
                    <a:ext uri="{9D8B030D-6E8A-4147-A177-3AD203B41FA5}">
                      <a16:colId xmlns:a16="http://schemas.microsoft.com/office/drawing/2014/main" val="1188045211"/>
                    </a:ext>
                  </a:extLst>
                </a:gridCol>
                <a:gridCol w="1562298">
                  <a:extLst>
                    <a:ext uri="{9D8B030D-6E8A-4147-A177-3AD203B41FA5}">
                      <a16:colId xmlns:a16="http://schemas.microsoft.com/office/drawing/2014/main" val="1627647855"/>
                    </a:ext>
                  </a:extLst>
                </a:gridCol>
              </a:tblGrid>
              <a:tr h="889799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Patient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Ventilation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esucitation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notropic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support 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Heart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Failure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edication</a:t>
                      </a:r>
                      <a:endParaRPr lang="de-DE" sz="11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VIG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reation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ASD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2026410288"/>
                  </a:ext>
                </a:extLst>
              </a:tr>
              <a:tr h="279188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1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, NE, M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(BLS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FO evident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1333924574"/>
                  </a:ext>
                </a:extLst>
              </a:tr>
              <a:tr h="207054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2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,M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 (BLS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1729078831"/>
                  </a:ext>
                </a:extLst>
              </a:tr>
              <a:tr h="207054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3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, L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(BLS) 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956103878"/>
                  </a:ext>
                </a:extLst>
              </a:tr>
              <a:tr h="207054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4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, L 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(BLS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2466319785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98AA6BCE-8E52-DDC1-CCA4-3909ACB301AA}"/>
              </a:ext>
            </a:extLst>
          </p:cNvPr>
          <p:cNvSpPr txBox="1"/>
          <p:nvPr/>
        </p:nvSpPr>
        <p:spPr>
          <a:xfrm>
            <a:off x="302458" y="645354"/>
            <a:ext cx="72027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able 1b: Therapeutic information of the patient cohort at admission  </a:t>
            </a:r>
          </a:p>
        </p:txBody>
      </p:sp>
    </p:spTree>
    <p:extLst>
      <p:ext uri="{BB962C8B-B14F-4D97-AF65-F5344CB8AC3E}">
        <p14:creationId xmlns:p14="http://schemas.microsoft.com/office/powerpoint/2010/main" val="2971477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57056967-88B3-F859-C6A9-3212A6E1E9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3501168"/>
              </p:ext>
            </p:extLst>
          </p:nvPr>
        </p:nvGraphicFramePr>
        <p:xfrm>
          <a:off x="545231" y="1129654"/>
          <a:ext cx="11316688" cy="107638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57502">
                  <a:extLst>
                    <a:ext uri="{9D8B030D-6E8A-4147-A177-3AD203B41FA5}">
                      <a16:colId xmlns:a16="http://schemas.microsoft.com/office/drawing/2014/main" val="2933525063"/>
                    </a:ext>
                  </a:extLst>
                </a:gridCol>
                <a:gridCol w="818460">
                  <a:extLst>
                    <a:ext uri="{9D8B030D-6E8A-4147-A177-3AD203B41FA5}">
                      <a16:colId xmlns:a16="http://schemas.microsoft.com/office/drawing/2014/main" val="683605248"/>
                    </a:ext>
                  </a:extLst>
                </a:gridCol>
                <a:gridCol w="636246">
                  <a:extLst>
                    <a:ext uri="{9D8B030D-6E8A-4147-A177-3AD203B41FA5}">
                      <a16:colId xmlns:a16="http://schemas.microsoft.com/office/drawing/2014/main" val="885887954"/>
                    </a:ext>
                  </a:extLst>
                </a:gridCol>
                <a:gridCol w="1166417">
                  <a:extLst>
                    <a:ext uri="{9D8B030D-6E8A-4147-A177-3AD203B41FA5}">
                      <a16:colId xmlns:a16="http://schemas.microsoft.com/office/drawing/2014/main" val="4019712377"/>
                    </a:ext>
                  </a:extLst>
                </a:gridCol>
                <a:gridCol w="1139621">
                  <a:extLst>
                    <a:ext uri="{9D8B030D-6E8A-4147-A177-3AD203B41FA5}">
                      <a16:colId xmlns:a16="http://schemas.microsoft.com/office/drawing/2014/main" val="1025170877"/>
                    </a:ext>
                  </a:extLst>
                </a:gridCol>
                <a:gridCol w="1602285">
                  <a:extLst>
                    <a:ext uri="{9D8B030D-6E8A-4147-A177-3AD203B41FA5}">
                      <a16:colId xmlns:a16="http://schemas.microsoft.com/office/drawing/2014/main" val="1306422157"/>
                    </a:ext>
                  </a:extLst>
                </a:gridCol>
                <a:gridCol w="1298612">
                  <a:extLst>
                    <a:ext uri="{9D8B030D-6E8A-4147-A177-3AD203B41FA5}">
                      <a16:colId xmlns:a16="http://schemas.microsoft.com/office/drawing/2014/main" val="1911046200"/>
                    </a:ext>
                  </a:extLst>
                </a:gridCol>
                <a:gridCol w="2280613">
                  <a:extLst>
                    <a:ext uri="{9D8B030D-6E8A-4147-A177-3AD203B41FA5}">
                      <a16:colId xmlns:a16="http://schemas.microsoft.com/office/drawing/2014/main" val="4162284064"/>
                    </a:ext>
                  </a:extLst>
                </a:gridCol>
                <a:gridCol w="808466">
                  <a:extLst>
                    <a:ext uri="{9D8B030D-6E8A-4147-A177-3AD203B41FA5}">
                      <a16:colId xmlns:a16="http://schemas.microsoft.com/office/drawing/2014/main" val="410909082"/>
                    </a:ext>
                  </a:extLst>
                </a:gridCol>
                <a:gridCol w="808466">
                  <a:extLst>
                    <a:ext uri="{9D8B030D-6E8A-4147-A177-3AD203B41FA5}">
                      <a16:colId xmlns:a16="http://schemas.microsoft.com/office/drawing/2014/main" val="199408152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Patient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RI -LVEF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VEF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VEDd in mm </a:t>
                      </a:r>
                    </a:p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z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score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NP-Level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/ml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Heart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Failure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edication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artial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ebanding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essure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Gradient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efore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ebanding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Follow-Up (</a:t>
                      </a:r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ars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odified</a:t>
                      </a:r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Ross 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3541829771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1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9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2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4 (+0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BLS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0mmHg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3545974642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2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7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5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 (+0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BLS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5mmHg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2422990643"/>
                  </a:ext>
                </a:extLst>
              </a:tr>
              <a:tr h="238181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3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4 (+0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BLS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5mmHg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3149724950"/>
                  </a:ext>
                </a:extLst>
              </a:tr>
              <a:tr h="15385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4 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8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2 (+0)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 BLS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0mmHg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2940" marR="62940" marT="0" marB="0"/>
                </a:tc>
                <a:tc>
                  <a:txBody>
                    <a:bodyPr/>
                    <a:lstStyle/>
                    <a:p>
                      <a:r>
                        <a:rPr lang="de-DE" sz="11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62940" marR="62940" marT="0" marB="0"/>
                </a:tc>
                <a:extLst>
                  <a:ext uri="{0D108BD9-81ED-4DB2-BD59-A6C34878D82A}">
                    <a16:rowId xmlns:a16="http://schemas.microsoft.com/office/drawing/2014/main" val="1044675035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7A89E9F1-0BA7-3D9C-772D-1BD0F0517197}"/>
              </a:ext>
            </a:extLst>
          </p:cNvPr>
          <p:cNvSpPr txBox="1"/>
          <p:nvPr/>
        </p:nvSpPr>
        <p:spPr>
          <a:xfrm>
            <a:off x="545230" y="798614"/>
            <a:ext cx="28599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able 2: Follow-up Data </a:t>
            </a:r>
          </a:p>
        </p:txBody>
      </p:sp>
    </p:spTree>
    <p:extLst>
      <p:ext uri="{BB962C8B-B14F-4D97-AF65-F5344CB8AC3E}">
        <p14:creationId xmlns:p14="http://schemas.microsoft.com/office/powerpoint/2010/main" val="1964445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id="{05C52AA6-BD9B-D53B-47D2-F8E146F4F7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9413315"/>
              </p:ext>
            </p:extLst>
          </p:nvPr>
        </p:nvGraphicFramePr>
        <p:xfrm>
          <a:off x="478545" y="1457907"/>
          <a:ext cx="11051815" cy="14630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18364">
                  <a:extLst>
                    <a:ext uri="{9D8B030D-6E8A-4147-A177-3AD203B41FA5}">
                      <a16:colId xmlns:a16="http://schemas.microsoft.com/office/drawing/2014/main" val="3788588941"/>
                    </a:ext>
                  </a:extLst>
                </a:gridCol>
                <a:gridCol w="1743462">
                  <a:extLst>
                    <a:ext uri="{9D8B030D-6E8A-4147-A177-3AD203B41FA5}">
                      <a16:colId xmlns:a16="http://schemas.microsoft.com/office/drawing/2014/main" val="4121675992"/>
                    </a:ext>
                  </a:extLst>
                </a:gridCol>
                <a:gridCol w="1333278">
                  <a:extLst>
                    <a:ext uri="{9D8B030D-6E8A-4147-A177-3AD203B41FA5}">
                      <a16:colId xmlns:a16="http://schemas.microsoft.com/office/drawing/2014/main" val="3386748899"/>
                    </a:ext>
                  </a:extLst>
                </a:gridCol>
                <a:gridCol w="761433">
                  <a:extLst>
                    <a:ext uri="{9D8B030D-6E8A-4147-A177-3AD203B41FA5}">
                      <a16:colId xmlns:a16="http://schemas.microsoft.com/office/drawing/2014/main" val="4227655437"/>
                    </a:ext>
                  </a:extLst>
                </a:gridCol>
                <a:gridCol w="879303">
                  <a:extLst>
                    <a:ext uri="{9D8B030D-6E8A-4147-A177-3AD203B41FA5}">
                      <a16:colId xmlns:a16="http://schemas.microsoft.com/office/drawing/2014/main" val="995032245"/>
                    </a:ext>
                  </a:extLst>
                </a:gridCol>
                <a:gridCol w="1511241">
                  <a:extLst>
                    <a:ext uri="{9D8B030D-6E8A-4147-A177-3AD203B41FA5}">
                      <a16:colId xmlns:a16="http://schemas.microsoft.com/office/drawing/2014/main" val="1693287070"/>
                    </a:ext>
                  </a:extLst>
                </a:gridCol>
                <a:gridCol w="1154592">
                  <a:extLst>
                    <a:ext uri="{9D8B030D-6E8A-4147-A177-3AD203B41FA5}">
                      <a16:colId xmlns:a16="http://schemas.microsoft.com/office/drawing/2014/main" val="2412202257"/>
                    </a:ext>
                  </a:extLst>
                </a:gridCol>
                <a:gridCol w="899222">
                  <a:extLst>
                    <a:ext uri="{9D8B030D-6E8A-4147-A177-3AD203B41FA5}">
                      <a16:colId xmlns:a16="http://schemas.microsoft.com/office/drawing/2014/main" val="1724562932"/>
                    </a:ext>
                  </a:extLst>
                </a:gridCol>
                <a:gridCol w="1017865">
                  <a:extLst>
                    <a:ext uri="{9D8B030D-6E8A-4147-A177-3AD203B41FA5}">
                      <a16:colId xmlns:a16="http://schemas.microsoft.com/office/drawing/2014/main" val="672863947"/>
                    </a:ext>
                  </a:extLst>
                </a:gridCol>
                <a:gridCol w="1033055">
                  <a:extLst>
                    <a:ext uri="{9D8B030D-6E8A-4147-A177-3AD203B41FA5}">
                      <a16:colId xmlns:a16="http://schemas.microsoft.com/office/drawing/2014/main" val="318734288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Patient 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Time of 1. EMB 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T-lymphocyte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Necrosis (grading)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Fibrosis 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Time of 2. EMB 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T-lymphcyte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ecrosi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Fibrosi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Persistence of ParvoB19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057045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1 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3 weeks after diagnosi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&gt;150/mm2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ye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6 weeks after disease beginning </a:t>
                      </a:r>
                      <a:r>
                        <a:rPr lang="en-US" sz="800" kern="100">
                          <a:effectLst/>
                        </a:rPr>
                        <a:t> 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100</a:t>
                      </a:r>
                      <a:r>
                        <a:rPr lang="en-US" sz="1200" kern="100" dirty="0">
                          <a:effectLst/>
                        </a:rPr>
                        <a:t>/mm2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iffuse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ye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5472807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2 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8 weeks after diagnosi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75/mm2</a:t>
                      </a:r>
                      <a:endParaRPr lang="de-DE" sz="1200" kern="100" dirty="0">
                        <a:effectLst/>
                        <a:highlight>
                          <a:srgbClr val="FFFF00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iffuse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5 years (after PAB)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de-DE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iffus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ye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8834162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3 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3 weeks after diagnosis</a:t>
                      </a:r>
                      <a:endParaRPr lang="de-DE" sz="1200" kern="100">
                        <a:effectLst/>
                      </a:endParaRPr>
                    </a:p>
                    <a:p>
                      <a:r>
                        <a:rPr lang="en-US" sz="1200" kern="100">
                          <a:effectLst/>
                        </a:rPr>
                        <a:t> 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&gt;100/mm2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iffuse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5 years (after PAB)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 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inor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ye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537277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4 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2 weeks after diagnosis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70/mm2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diffuse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1 year (after PAB)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Yes (12/mm2)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no</a:t>
                      </a:r>
                      <a:endParaRPr lang="de-D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de-DE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inor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effectLst/>
                        </a:rPr>
                        <a:t>yes</a:t>
                      </a:r>
                      <a:endParaRPr lang="de-D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29484175"/>
                  </a:ext>
                </a:extLst>
              </a:tr>
            </a:tbl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:a16="http://schemas.microsoft.com/office/drawing/2014/main" id="{DDDE5BA0-28B8-32FF-D591-ACE0A998D00E}"/>
              </a:ext>
            </a:extLst>
          </p:cNvPr>
          <p:cNvSpPr txBox="1"/>
          <p:nvPr/>
        </p:nvSpPr>
        <p:spPr>
          <a:xfrm>
            <a:off x="541610" y="881175"/>
            <a:ext cx="24499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Table 3: </a:t>
            </a:r>
            <a:r>
              <a:rPr lang="de-DE" sz="1600" dirty="0" err="1"/>
              <a:t>Histological</a:t>
            </a:r>
            <a:r>
              <a:rPr lang="de-DE" sz="1600" dirty="0"/>
              <a:t> Data </a:t>
            </a:r>
          </a:p>
        </p:txBody>
      </p:sp>
    </p:spTree>
    <p:extLst>
      <p:ext uri="{BB962C8B-B14F-4D97-AF65-F5344CB8AC3E}">
        <p14:creationId xmlns:p14="http://schemas.microsoft.com/office/powerpoint/2010/main" val="27142228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F38CC26-E6CC-615A-243C-F17F0BF58CF0}"/>
              </a:ext>
            </a:extLst>
          </p:cNvPr>
          <p:cNvSpPr txBox="1"/>
          <p:nvPr/>
        </p:nvSpPr>
        <p:spPr>
          <a:xfrm>
            <a:off x="812800" y="1000785"/>
            <a:ext cx="1742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RI </a:t>
            </a:r>
            <a:r>
              <a:rPr lang="de-DE" dirty="0" err="1"/>
              <a:t>before</a:t>
            </a:r>
            <a:r>
              <a:rPr lang="de-DE" dirty="0"/>
              <a:t> PAB 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824A4EB1-1E6B-1B47-2888-357BBACD9187}"/>
              </a:ext>
            </a:extLst>
          </p:cNvPr>
          <p:cNvSpPr txBox="1"/>
          <p:nvPr/>
        </p:nvSpPr>
        <p:spPr>
          <a:xfrm>
            <a:off x="3501069" y="982673"/>
            <a:ext cx="5867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RI after </a:t>
            </a:r>
            <a:r>
              <a:rPr lang="de-DE" dirty="0" err="1"/>
              <a:t>Cre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rASD</a:t>
            </a:r>
            <a:r>
              <a:rPr lang="de-DE" dirty="0"/>
              <a:t> and </a:t>
            </a:r>
            <a:r>
              <a:rPr lang="de-DE" dirty="0" err="1"/>
              <a:t>Pulmonary</a:t>
            </a:r>
            <a:r>
              <a:rPr lang="de-DE" dirty="0"/>
              <a:t> </a:t>
            </a:r>
            <a:r>
              <a:rPr lang="de-DE" dirty="0" err="1"/>
              <a:t>Artery</a:t>
            </a:r>
            <a:r>
              <a:rPr lang="de-DE" dirty="0"/>
              <a:t> Banding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B7EB9321-176F-1EF4-E653-56C91C55ECEE}"/>
              </a:ext>
            </a:extLst>
          </p:cNvPr>
          <p:cNvSpPr txBox="1"/>
          <p:nvPr/>
        </p:nvSpPr>
        <p:spPr>
          <a:xfrm>
            <a:off x="812800" y="3589755"/>
            <a:ext cx="1811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EMB </a:t>
            </a:r>
            <a:r>
              <a:rPr lang="de-DE" dirty="0" err="1"/>
              <a:t>before</a:t>
            </a:r>
            <a:r>
              <a:rPr lang="de-DE" dirty="0"/>
              <a:t> PAB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22E3B46-D9FE-2297-8BD1-EA88F652FB43}"/>
              </a:ext>
            </a:extLst>
          </p:cNvPr>
          <p:cNvSpPr txBox="1"/>
          <p:nvPr/>
        </p:nvSpPr>
        <p:spPr>
          <a:xfrm>
            <a:off x="7453769" y="3521506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EMB partial </a:t>
            </a:r>
            <a:r>
              <a:rPr lang="de-DE" dirty="0" err="1"/>
              <a:t>Debanding</a:t>
            </a:r>
            <a:endParaRPr lang="de-DE" dirty="0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717D2E72-09B0-4761-E09D-0721288129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1736" y="4214238"/>
            <a:ext cx="2080333" cy="1542247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D94D2145-DE47-2AC6-A14A-A04BED5196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800" y="4214238"/>
            <a:ext cx="2080333" cy="1542247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6BF26BCF-9490-20B3-14E2-C91563FEED14}"/>
              </a:ext>
            </a:extLst>
          </p:cNvPr>
          <p:cNvSpPr txBox="1"/>
          <p:nvPr/>
        </p:nvSpPr>
        <p:spPr>
          <a:xfrm>
            <a:off x="3180949" y="5895610"/>
            <a:ext cx="2190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HCII+ </a:t>
            </a:r>
            <a:r>
              <a:rPr lang="de-DE" dirty="0" err="1"/>
              <a:t>macrophages</a:t>
            </a:r>
            <a:endParaRPr lang="de-DE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621AA02-C114-595D-B524-8A47864CB424}"/>
              </a:ext>
            </a:extLst>
          </p:cNvPr>
          <p:cNvSpPr txBox="1"/>
          <p:nvPr/>
        </p:nvSpPr>
        <p:spPr>
          <a:xfrm>
            <a:off x="869846" y="5981225"/>
            <a:ext cx="1917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asson </a:t>
            </a:r>
            <a:r>
              <a:rPr lang="de-DE" dirty="0" err="1"/>
              <a:t>Trichrome</a:t>
            </a:r>
            <a:endParaRPr lang="de-DE" dirty="0"/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6C5D3386-48DE-FD2E-C940-573D14E31A4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0295" y="4124580"/>
            <a:ext cx="2080333" cy="1542247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DCE198F8-38F2-46F1-91FA-9814972CA8D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9001" y="4124580"/>
            <a:ext cx="2080333" cy="1542247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89759CA7-235E-46D4-1EE5-4E085092E7E9}"/>
              </a:ext>
            </a:extLst>
          </p:cNvPr>
          <p:cNvSpPr txBox="1"/>
          <p:nvPr/>
        </p:nvSpPr>
        <p:spPr>
          <a:xfrm>
            <a:off x="9682431" y="5745140"/>
            <a:ext cx="2190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HCII+ </a:t>
            </a:r>
            <a:r>
              <a:rPr lang="de-DE" dirty="0" err="1"/>
              <a:t>macrophages</a:t>
            </a:r>
            <a:endParaRPr lang="de-DE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C43E8D5-2156-4C17-E8E7-67B0CEE30C0E}"/>
              </a:ext>
            </a:extLst>
          </p:cNvPr>
          <p:cNvSpPr txBox="1"/>
          <p:nvPr/>
        </p:nvSpPr>
        <p:spPr>
          <a:xfrm>
            <a:off x="7453769" y="5797736"/>
            <a:ext cx="1917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asson </a:t>
            </a:r>
            <a:r>
              <a:rPr lang="de-DE" dirty="0" err="1"/>
              <a:t>Trichrome</a:t>
            </a:r>
            <a:endParaRPr lang="de-DE" dirty="0"/>
          </a:p>
        </p:txBody>
      </p:sp>
      <p:pic>
        <p:nvPicPr>
          <p:cNvPr id="15" name="Grafik 14" descr="Ein Bild, das Screenshot enthält.&#10;&#10;KI-generierte Inhalte können fehlerhaft sein.">
            <a:extLst>
              <a:ext uri="{FF2B5EF4-FFF2-40B4-BE49-F238E27FC236}">
                <a16:creationId xmlns:a16="http://schemas.microsoft.com/office/drawing/2014/main" id="{8D96CB09-E54A-BF7C-4DF7-8848292D51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319" y="1494391"/>
            <a:ext cx="2120814" cy="2095364"/>
          </a:xfrm>
          <a:prstGeom prst="rect">
            <a:avLst/>
          </a:prstGeom>
        </p:spPr>
      </p:pic>
      <p:pic>
        <p:nvPicPr>
          <p:cNvPr id="17" name="Grafik 16" descr="Ein Bild, das Kreis, Screenshot enthält.&#10;&#10;KI-generierte Inhalte können fehlerhaft sein.">
            <a:extLst>
              <a:ext uri="{FF2B5EF4-FFF2-40B4-BE49-F238E27FC236}">
                <a16:creationId xmlns:a16="http://schemas.microsoft.com/office/drawing/2014/main" id="{8EA4A873-08BC-9E13-6EE4-29C9017C52C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53769" y="1506670"/>
            <a:ext cx="2802079" cy="1936523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FD61CF7F-92FA-0005-7E17-9FB89EFFD8A2}"/>
              </a:ext>
            </a:extLst>
          </p:cNvPr>
          <p:cNvSpPr txBox="1"/>
          <p:nvPr/>
        </p:nvSpPr>
        <p:spPr>
          <a:xfrm>
            <a:off x="772319" y="519083"/>
            <a:ext cx="37984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/>
              <a:t>Supplementary</a:t>
            </a:r>
            <a:r>
              <a:rPr lang="de-DE" sz="2000" b="1" dirty="0"/>
              <a:t> Data Patient #2</a:t>
            </a:r>
          </a:p>
        </p:txBody>
      </p:sp>
    </p:spTree>
    <p:extLst>
      <p:ext uri="{BB962C8B-B14F-4D97-AF65-F5344CB8AC3E}">
        <p14:creationId xmlns:p14="http://schemas.microsoft.com/office/powerpoint/2010/main" val="2140245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0</Words>
  <Application>Microsoft Macintosh PowerPoint</Application>
  <PresentationFormat>Breitbild</PresentationFormat>
  <Paragraphs>291</Paragraphs>
  <Slides>6</Slides>
  <Notes>5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Inter</vt:lpstr>
      <vt:lpstr>Times New Roman</vt:lpstr>
      <vt:lpstr>Office</vt:lpstr>
      <vt:lpstr>Case Series: Full Recovery in Severe ParvoB19 Myocarditis with DCM Phenotype: The Impact of rASD Creation and Pulmonary Banding  Tables and Figures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ta und Graphics Parvo B19 Myocarditis </dc:title>
  <dc:creator>Julian Kappich</dc:creator>
  <cp:lastModifiedBy>Julian Kappich</cp:lastModifiedBy>
  <cp:revision>26</cp:revision>
  <dcterms:created xsi:type="dcterms:W3CDTF">2025-01-04T14:54:33Z</dcterms:created>
  <dcterms:modified xsi:type="dcterms:W3CDTF">2025-05-21T08:52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efa4170-0d19-0005-0004-bc88714345d2_Enabled">
    <vt:lpwstr>true</vt:lpwstr>
  </property>
  <property fmtid="{D5CDD505-2E9C-101B-9397-08002B2CF9AE}" pid="3" name="MSIP_Label_defa4170-0d19-0005-0004-bc88714345d2_SetDate">
    <vt:lpwstr>2025-01-07T12:30:42Z</vt:lpwstr>
  </property>
  <property fmtid="{D5CDD505-2E9C-101B-9397-08002B2CF9AE}" pid="4" name="MSIP_Label_defa4170-0d19-0005-0004-bc88714345d2_Method">
    <vt:lpwstr>Standard</vt:lpwstr>
  </property>
  <property fmtid="{D5CDD505-2E9C-101B-9397-08002B2CF9AE}" pid="5" name="MSIP_Label_defa4170-0d19-0005-0004-bc88714345d2_Name">
    <vt:lpwstr>defa4170-0d19-0005-0004-bc88714345d2</vt:lpwstr>
  </property>
  <property fmtid="{D5CDD505-2E9C-101B-9397-08002B2CF9AE}" pid="6" name="MSIP_Label_defa4170-0d19-0005-0004-bc88714345d2_SiteId">
    <vt:lpwstr>e9da4ac1-f26f-485f-83ae-d88639088028</vt:lpwstr>
  </property>
  <property fmtid="{D5CDD505-2E9C-101B-9397-08002B2CF9AE}" pid="7" name="MSIP_Label_defa4170-0d19-0005-0004-bc88714345d2_ActionId">
    <vt:lpwstr>834e578f-7870-4300-b457-048d7913880f</vt:lpwstr>
  </property>
  <property fmtid="{D5CDD505-2E9C-101B-9397-08002B2CF9AE}" pid="8" name="MSIP_Label_defa4170-0d19-0005-0004-bc88714345d2_ContentBits">
    <vt:lpwstr>0</vt:lpwstr>
  </property>
</Properties>
</file>